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72" r:id="rId2"/>
    <p:sldId id="273" r:id="rId3"/>
    <p:sldId id="271" r:id="rId4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050"/>
    <a:srgbClr val="F4E69B"/>
    <a:srgbClr val="F2A463"/>
    <a:srgbClr val="FFD5D6"/>
    <a:srgbClr val="EBBB95"/>
    <a:srgbClr val="BFBFBF"/>
    <a:srgbClr val="6B7074"/>
    <a:srgbClr val="1575EE"/>
    <a:srgbClr val="A1FE9F"/>
    <a:srgbClr val="8EBE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F76208C-2E5E-4B7A-9DC2-8E55EE812045}" v="2" dt="2025-11-22T21:20:21.10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3" d="100"/>
          <a:sy n="103" d="100"/>
        </p:scale>
        <p:origin x="681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nhaiya Singh" userId="805bf14c-1082-4cfd-9353-37578bbd1fb1" providerId="ADAL" clId="{79B1CC82-000B-47B7-A3EA-1BFC74FB95B7}"/>
    <pc:docChg chg="custSel modSld">
      <pc:chgData name="Kanhaiya Singh" userId="805bf14c-1082-4cfd-9353-37578bbd1fb1" providerId="ADAL" clId="{79B1CC82-000B-47B7-A3EA-1BFC74FB95B7}" dt="2025-11-05T01:53:34.124" v="38" actId="1076"/>
      <pc:docMkLst>
        <pc:docMk/>
      </pc:docMkLst>
      <pc:sldChg chg="modSp mod">
        <pc:chgData name="Kanhaiya Singh" userId="805bf14c-1082-4cfd-9353-37578bbd1fb1" providerId="ADAL" clId="{79B1CC82-000B-47B7-A3EA-1BFC74FB95B7}" dt="2025-11-05T01:49:00.233" v="0" actId="1076"/>
        <pc:sldMkLst>
          <pc:docMk/>
          <pc:sldMk cId="694214781" sldId="258"/>
        </pc:sldMkLst>
      </pc:sldChg>
      <pc:sldChg chg="addSp modSp mod">
        <pc:chgData name="Kanhaiya Singh" userId="805bf14c-1082-4cfd-9353-37578bbd1fb1" providerId="ADAL" clId="{79B1CC82-000B-47B7-A3EA-1BFC74FB95B7}" dt="2025-11-05T01:53:34.124" v="38" actId="1076"/>
        <pc:sldMkLst>
          <pc:docMk/>
          <pc:sldMk cId="3525251647" sldId="268"/>
        </pc:sldMkLst>
      </pc:sldChg>
    </pc:docChg>
  </pc:docChgLst>
  <pc:docChgLst>
    <pc:chgData name="Kanhaiya Singh" userId="805bf14c-1082-4cfd-9353-37578bbd1fb1" providerId="ADAL" clId="{862C6BDB-154E-4EF5-BABE-2F64962912A3}"/>
    <pc:docChg chg="undo custSel addSld delSld modSld sldOrd">
      <pc:chgData name="Kanhaiya Singh" userId="805bf14c-1082-4cfd-9353-37578bbd1fb1" providerId="ADAL" clId="{862C6BDB-154E-4EF5-BABE-2F64962912A3}" dt="2025-11-22T21:20:44.944" v="4535" actId="20577"/>
      <pc:docMkLst>
        <pc:docMk/>
      </pc:docMkLst>
      <pc:sldChg chg="del">
        <pc:chgData name="Kanhaiya Singh" userId="805bf14c-1082-4cfd-9353-37578bbd1fb1" providerId="ADAL" clId="{862C6BDB-154E-4EF5-BABE-2F64962912A3}" dt="2025-11-05T18:55:38.155" v="4517" actId="47"/>
        <pc:sldMkLst>
          <pc:docMk/>
          <pc:sldMk cId="3710195747" sldId="256"/>
        </pc:sldMkLst>
      </pc:sldChg>
      <pc:sldChg chg="addSp delSp modSp del mod">
        <pc:chgData name="Kanhaiya Singh" userId="805bf14c-1082-4cfd-9353-37578bbd1fb1" providerId="ADAL" clId="{862C6BDB-154E-4EF5-BABE-2F64962912A3}" dt="2025-11-05T18:55:19.945" v="4516" actId="47"/>
        <pc:sldMkLst>
          <pc:docMk/>
          <pc:sldMk cId="4201213494" sldId="257"/>
        </pc:sldMkLst>
      </pc:sldChg>
      <pc:sldChg chg="addSp delSp modSp new del mod">
        <pc:chgData name="Kanhaiya Singh" userId="805bf14c-1082-4cfd-9353-37578bbd1fb1" providerId="ADAL" clId="{862C6BDB-154E-4EF5-BABE-2F64962912A3}" dt="2025-11-05T18:55:19.945" v="4516" actId="47"/>
        <pc:sldMkLst>
          <pc:docMk/>
          <pc:sldMk cId="694214781" sldId="258"/>
        </pc:sldMkLst>
      </pc:sldChg>
      <pc:sldChg chg="addSp delSp new del mod">
        <pc:chgData name="Kanhaiya Singh" userId="805bf14c-1082-4cfd-9353-37578bbd1fb1" providerId="ADAL" clId="{862C6BDB-154E-4EF5-BABE-2F64962912A3}" dt="2025-11-05T18:55:38.155" v="4517" actId="47"/>
        <pc:sldMkLst>
          <pc:docMk/>
          <pc:sldMk cId="2567448054" sldId="259"/>
        </pc:sldMkLst>
      </pc:sldChg>
      <pc:sldChg chg="addSp delSp modSp new del mod">
        <pc:chgData name="Kanhaiya Singh" userId="805bf14c-1082-4cfd-9353-37578bbd1fb1" providerId="ADAL" clId="{862C6BDB-154E-4EF5-BABE-2F64962912A3}" dt="2025-11-05T18:55:19.945" v="4516" actId="47"/>
        <pc:sldMkLst>
          <pc:docMk/>
          <pc:sldMk cId="1484020929" sldId="260"/>
        </pc:sldMkLst>
      </pc:sldChg>
      <pc:sldChg chg="addSp delSp modSp new del mod">
        <pc:chgData name="Kanhaiya Singh" userId="805bf14c-1082-4cfd-9353-37578bbd1fb1" providerId="ADAL" clId="{862C6BDB-154E-4EF5-BABE-2F64962912A3}" dt="2025-11-05T18:55:19.945" v="4516" actId="47"/>
        <pc:sldMkLst>
          <pc:docMk/>
          <pc:sldMk cId="3831754518" sldId="261"/>
        </pc:sldMkLst>
      </pc:sldChg>
      <pc:sldChg chg="addSp delSp modSp new del mod ord">
        <pc:chgData name="Kanhaiya Singh" userId="805bf14c-1082-4cfd-9353-37578bbd1fb1" providerId="ADAL" clId="{862C6BDB-154E-4EF5-BABE-2F64962912A3}" dt="2025-11-05T18:55:38.155" v="4517" actId="47"/>
        <pc:sldMkLst>
          <pc:docMk/>
          <pc:sldMk cId="786751072" sldId="262"/>
        </pc:sldMkLst>
      </pc:sldChg>
      <pc:sldChg chg="addSp delSp modSp new del mod ord">
        <pc:chgData name="Kanhaiya Singh" userId="805bf14c-1082-4cfd-9353-37578bbd1fb1" providerId="ADAL" clId="{862C6BDB-154E-4EF5-BABE-2F64962912A3}" dt="2025-11-05T18:55:38.155" v="4517" actId="47"/>
        <pc:sldMkLst>
          <pc:docMk/>
          <pc:sldMk cId="185809573" sldId="263"/>
        </pc:sldMkLst>
      </pc:sldChg>
      <pc:sldChg chg="addSp delSp modSp new del mod ord">
        <pc:chgData name="Kanhaiya Singh" userId="805bf14c-1082-4cfd-9353-37578bbd1fb1" providerId="ADAL" clId="{862C6BDB-154E-4EF5-BABE-2F64962912A3}" dt="2025-11-05T18:55:38.155" v="4517" actId="47"/>
        <pc:sldMkLst>
          <pc:docMk/>
          <pc:sldMk cId="3832555433" sldId="264"/>
        </pc:sldMkLst>
      </pc:sldChg>
      <pc:sldChg chg="addSp delSp modSp new del mod ord">
        <pc:chgData name="Kanhaiya Singh" userId="805bf14c-1082-4cfd-9353-37578bbd1fb1" providerId="ADAL" clId="{862C6BDB-154E-4EF5-BABE-2F64962912A3}" dt="2025-11-05T18:55:38.155" v="4517" actId="47"/>
        <pc:sldMkLst>
          <pc:docMk/>
          <pc:sldMk cId="1892371843" sldId="265"/>
        </pc:sldMkLst>
      </pc:sldChg>
      <pc:sldChg chg="addSp delSp modSp new del mod ord">
        <pc:chgData name="Kanhaiya Singh" userId="805bf14c-1082-4cfd-9353-37578bbd1fb1" providerId="ADAL" clId="{862C6BDB-154E-4EF5-BABE-2F64962912A3}" dt="2025-11-05T18:55:38.155" v="4517" actId="47"/>
        <pc:sldMkLst>
          <pc:docMk/>
          <pc:sldMk cId="181154783" sldId="266"/>
        </pc:sldMkLst>
      </pc:sldChg>
      <pc:sldChg chg="addSp delSp modSp new del mod ord">
        <pc:chgData name="Kanhaiya Singh" userId="805bf14c-1082-4cfd-9353-37578bbd1fb1" providerId="ADAL" clId="{862C6BDB-154E-4EF5-BABE-2F64962912A3}" dt="2025-11-05T18:55:38.155" v="4517" actId="47"/>
        <pc:sldMkLst>
          <pc:docMk/>
          <pc:sldMk cId="2574371031" sldId="267"/>
        </pc:sldMkLst>
      </pc:sldChg>
      <pc:sldChg chg="addSp delSp modSp new del mod">
        <pc:chgData name="Kanhaiya Singh" userId="805bf14c-1082-4cfd-9353-37578bbd1fb1" providerId="ADAL" clId="{862C6BDB-154E-4EF5-BABE-2F64962912A3}" dt="2025-11-05T18:55:19.945" v="4516" actId="47"/>
        <pc:sldMkLst>
          <pc:docMk/>
          <pc:sldMk cId="3525251647" sldId="268"/>
        </pc:sldMkLst>
      </pc:sldChg>
      <pc:sldChg chg="addSp delSp modSp new del mod ord">
        <pc:chgData name="Kanhaiya Singh" userId="805bf14c-1082-4cfd-9353-37578bbd1fb1" providerId="ADAL" clId="{862C6BDB-154E-4EF5-BABE-2F64962912A3}" dt="2025-11-03T14:07:50.758" v="2030" actId="47"/>
        <pc:sldMkLst>
          <pc:docMk/>
          <pc:sldMk cId="4234783010" sldId="268"/>
        </pc:sldMkLst>
      </pc:sldChg>
      <pc:sldChg chg="addSp delSp new del mod ord">
        <pc:chgData name="Kanhaiya Singh" userId="805bf14c-1082-4cfd-9353-37578bbd1fb1" providerId="ADAL" clId="{862C6BDB-154E-4EF5-BABE-2F64962912A3}" dt="2025-11-05T18:55:38.155" v="4517" actId="47"/>
        <pc:sldMkLst>
          <pc:docMk/>
          <pc:sldMk cId="3671063493" sldId="269"/>
        </pc:sldMkLst>
      </pc:sldChg>
      <pc:sldChg chg="addSp delSp modSp new del mod">
        <pc:chgData name="Kanhaiya Singh" userId="805bf14c-1082-4cfd-9353-37578bbd1fb1" providerId="ADAL" clId="{862C6BDB-154E-4EF5-BABE-2F64962912A3}" dt="2025-11-05T18:55:19.945" v="4516" actId="47"/>
        <pc:sldMkLst>
          <pc:docMk/>
          <pc:sldMk cId="2934744223" sldId="270"/>
        </pc:sldMkLst>
      </pc:sldChg>
      <pc:sldChg chg="addSp delSp modSp new add del mod">
        <pc:chgData name="Kanhaiya Singh" userId="805bf14c-1082-4cfd-9353-37578bbd1fb1" providerId="ADAL" clId="{862C6BDB-154E-4EF5-BABE-2F64962912A3}" dt="2025-11-22T21:20:44.944" v="4535" actId="20577"/>
        <pc:sldMkLst>
          <pc:docMk/>
          <pc:sldMk cId="1190213292" sldId="271"/>
        </pc:sldMkLst>
        <pc:spChg chg="mod">
          <ac:chgData name="Kanhaiya Singh" userId="805bf14c-1082-4cfd-9353-37578bbd1fb1" providerId="ADAL" clId="{862C6BDB-154E-4EF5-BABE-2F64962912A3}" dt="2025-11-22T21:20:44.944" v="4535" actId="20577"/>
          <ac:spMkLst>
            <pc:docMk/>
            <pc:sldMk cId="1190213292" sldId="271"/>
            <ac:spMk id="5" creationId="{94F957AF-C282-ABA2-5F84-C993CC9981D9}"/>
          </ac:spMkLst>
        </pc:spChg>
      </pc:sldChg>
      <pc:sldChg chg="addSp delSp modSp new add del mod">
        <pc:chgData name="Kanhaiya Singh" userId="805bf14c-1082-4cfd-9353-37578bbd1fb1" providerId="ADAL" clId="{862C6BDB-154E-4EF5-BABE-2F64962912A3}" dt="2025-11-22T18:12:39.526" v="4528" actId="20577"/>
        <pc:sldMkLst>
          <pc:docMk/>
          <pc:sldMk cId="1116198581" sldId="272"/>
        </pc:sldMkLst>
        <pc:spChg chg="mod">
          <ac:chgData name="Kanhaiya Singh" userId="805bf14c-1082-4cfd-9353-37578bbd1fb1" providerId="ADAL" clId="{862C6BDB-154E-4EF5-BABE-2F64962912A3}" dt="2025-11-22T18:12:39.526" v="4528" actId="20577"/>
          <ac:spMkLst>
            <pc:docMk/>
            <pc:sldMk cId="1116198581" sldId="272"/>
            <ac:spMk id="6" creationId="{F0187C89-62BB-D2F3-5CC4-88715FFF9414}"/>
          </ac:spMkLst>
        </pc:spChg>
      </pc:sldChg>
      <pc:sldChg chg="addSp delSp modSp new mod ord">
        <pc:chgData name="Kanhaiya Singh" userId="805bf14c-1082-4cfd-9353-37578bbd1fb1" providerId="ADAL" clId="{862C6BDB-154E-4EF5-BABE-2F64962912A3}" dt="2025-11-22T18:12:32.141" v="4525"/>
        <pc:sldMkLst>
          <pc:docMk/>
          <pc:sldMk cId="2289186591" sldId="273"/>
        </pc:sldMkLst>
        <pc:spChg chg="add mod">
          <ac:chgData name="Kanhaiya Singh" userId="805bf14c-1082-4cfd-9353-37578bbd1fb1" providerId="ADAL" clId="{862C6BDB-154E-4EF5-BABE-2F64962912A3}" dt="2025-11-03T19:14:40.035" v="4040" actId="1076"/>
          <ac:spMkLst>
            <pc:docMk/>
            <pc:sldMk cId="2289186591" sldId="273"/>
            <ac:spMk id="6" creationId="{D12C053B-C5F3-F044-1559-D70BADD6221E}"/>
          </ac:spMkLst>
        </pc:spChg>
        <pc:picChg chg="add mod modCrop">
          <ac:chgData name="Kanhaiya Singh" userId="805bf14c-1082-4cfd-9353-37578bbd1fb1" providerId="ADAL" clId="{862C6BDB-154E-4EF5-BABE-2F64962912A3}" dt="2025-11-20T16:55:55.364" v="4522" actId="14100"/>
          <ac:picMkLst>
            <pc:docMk/>
            <pc:sldMk cId="2289186591" sldId="273"/>
            <ac:picMk id="5" creationId="{86C2AB5A-A07F-FE35-9FE7-344620523569}"/>
          </ac:picMkLst>
        </pc:picChg>
      </pc:sldChg>
      <pc:sldChg chg="delSp new del mod">
        <pc:chgData name="Kanhaiya Singh" userId="805bf14c-1082-4cfd-9353-37578bbd1fb1" providerId="ADAL" clId="{862C6BDB-154E-4EF5-BABE-2F64962912A3}" dt="2025-11-22T21:20:40.928" v="4533" actId="47"/>
        <pc:sldMkLst>
          <pc:docMk/>
          <pc:sldMk cId="1254111530" sldId="274"/>
        </pc:sldMkLst>
        <pc:spChg chg="del">
          <ac:chgData name="Kanhaiya Singh" userId="805bf14c-1082-4cfd-9353-37578bbd1fb1" providerId="ADAL" clId="{862C6BDB-154E-4EF5-BABE-2F64962912A3}" dt="2025-11-22T21:19:58.902" v="4531" actId="478"/>
          <ac:spMkLst>
            <pc:docMk/>
            <pc:sldMk cId="1254111530" sldId="274"/>
            <ac:spMk id="2" creationId="{852F760A-0760-CF42-3C2B-95FCACF586DD}"/>
          </ac:spMkLst>
        </pc:spChg>
        <pc:spChg chg="del">
          <ac:chgData name="Kanhaiya Singh" userId="805bf14c-1082-4cfd-9353-37578bbd1fb1" providerId="ADAL" clId="{862C6BDB-154E-4EF5-BABE-2F64962912A3}" dt="2025-11-22T21:19:58.902" v="4531" actId="478"/>
          <ac:spMkLst>
            <pc:docMk/>
            <pc:sldMk cId="1254111530" sldId="274"/>
            <ac:spMk id="3" creationId="{05CDC0A3-9D77-1051-B6F1-BBF26B169FA6}"/>
          </ac:spMkLst>
        </pc:spChg>
      </pc:sldChg>
      <pc:sldChg chg="delSp new del mod">
        <pc:chgData name="Kanhaiya Singh" userId="805bf14c-1082-4cfd-9353-37578bbd1fb1" providerId="ADAL" clId="{862C6BDB-154E-4EF5-BABE-2F64962912A3}" dt="2025-11-22T18:12:44.993" v="4529" actId="47"/>
        <pc:sldMkLst>
          <pc:docMk/>
          <pc:sldMk cId="3750515580" sldId="274"/>
        </pc:sldMkLst>
        <pc:spChg chg="del">
          <ac:chgData name="Kanhaiya Singh" userId="805bf14c-1082-4cfd-9353-37578bbd1fb1" providerId="ADAL" clId="{862C6BDB-154E-4EF5-BABE-2F64962912A3}" dt="2025-11-22T18:12:35.062" v="4526" actId="478"/>
          <ac:spMkLst>
            <pc:docMk/>
            <pc:sldMk cId="3750515580" sldId="274"/>
            <ac:spMk id="2" creationId="{CCD5647B-D84B-8056-6FE6-6A9E6D11F961}"/>
          </ac:spMkLst>
        </pc:spChg>
        <pc:spChg chg="del">
          <ac:chgData name="Kanhaiya Singh" userId="805bf14c-1082-4cfd-9353-37578bbd1fb1" providerId="ADAL" clId="{862C6BDB-154E-4EF5-BABE-2F64962912A3}" dt="2025-11-22T18:12:35.062" v="4526" actId="478"/>
          <ac:spMkLst>
            <pc:docMk/>
            <pc:sldMk cId="3750515580" sldId="274"/>
            <ac:spMk id="3" creationId="{3DD640E6-4F1A-7918-8561-D6F0BA419B0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AB0294-4907-4143-ACF2-BFC671D55923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BF947C-EF2B-4437-8112-6DC3FACC01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178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213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478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745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45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>
                    <a:tint val="82000"/>
                  </a:schemeClr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933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055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620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661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453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625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218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3780D2-97B7-4548-8A08-9DFE5D2538C2}" type="datetimeFigureOut">
              <a:rPr lang="en-US" smtClean="0"/>
              <a:t>1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195EE2-B2C5-4144-BC87-D2F28977F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722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6" Type="http://schemas.openxmlformats.org/officeDocument/2006/relationships/hyperlink" Target="https://www.ncbi.nlm.nih.gov/protein/P01031" TargetMode="External"/><Relationship Id="rId21" Type="http://schemas.openxmlformats.org/officeDocument/2006/relationships/hyperlink" Target="https://www.ncbi.nlm.nih.gov/protein/Q9NR99" TargetMode="External"/><Relationship Id="rId42" Type="http://schemas.openxmlformats.org/officeDocument/2006/relationships/hyperlink" Target="https://www.ncbi.nlm.nih.gov/protein/Q7LBR1" TargetMode="External"/><Relationship Id="rId47" Type="http://schemas.openxmlformats.org/officeDocument/2006/relationships/hyperlink" Target="https://www.ncbi.nlm.nih.gov/protein/P0C0L5" TargetMode="External"/><Relationship Id="rId63" Type="http://schemas.openxmlformats.org/officeDocument/2006/relationships/hyperlink" Target="https://www.ncbi.nlm.nih.gov/protein/Q32P28" TargetMode="External"/><Relationship Id="rId68" Type="http://schemas.openxmlformats.org/officeDocument/2006/relationships/hyperlink" Target="https://www.ncbi.nlm.nih.gov/protein/O43488" TargetMode="External"/><Relationship Id="rId2" Type="http://schemas.openxmlformats.org/officeDocument/2006/relationships/hyperlink" Target="https://www.ncbi.nlm.nih.gov/protein/Q9Y2V7" TargetMode="External"/><Relationship Id="rId16" Type="http://schemas.openxmlformats.org/officeDocument/2006/relationships/hyperlink" Target="https://www.ncbi.nlm.nih.gov/protein/P02647" TargetMode="External"/><Relationship Id="rId29" Type="http://schemas.openxmlformats.org/officeDocument/2006/relationships/hyperlink" Target="https://www.ncbi.nlm.nih.gov/protein/P05546" TargetMode="External"/><Relationship Id="rId11" Type="http://schemas.openxmlformats.org/officeDocument/2006/relationships/hyperlink" Target="https://www.ncbi.nlm.nih.gov/protein/P29622" TargetMode="External"/><Relationship Id="rId24" Type="http://schemas.openxmlformats.org/officeDocument/2006/relationships/hyperlink" Target="https://www.ncbi.nlm.nih.gov/protein/Q96AY3" TargetMode="External"/><Relationship Id="rId32" Type="http://schemas.openxmlformats.org/officeDocument/2006/relationships/hyperlink" Target="https://www.ncbi.nlm.nih.gov/protein/Q8TD16" TargetMode="External"/><Relationship Id="rId37" Type="http://schemas.openxmlformats.org/officeDocument/2006/relationships/hyperlink" Target="https://www.ncbi.nlm.nih.gov/protein/P07358" TargetMode="External"/><Relationship Id="rId40" Type="http://schemas.openxmlformats.org/officeDocument/2006/relationships/hyperlink" Target="https://www.ncbi.nlm.nih.gov/protein/Q96IY4" TargetMode="External"/><Relationship Id="rId45" Type="http://schemas.openxmlformats.org/officeDocument/2006/relationships/hyperlink" Target="https://www.ncbi.nlm.nih.gov/protein/Q9Y680" TargetMode="External"/><Relationship Id="rId53" Type="http://schemas.openxmlformats.org/officeDocument/2006/relationships/hyperlink" Target="https://www.ncbi.nlm.nih.gov/protein/Q14554" TargetMode="External"/><Relationship Id="rId58" Type="http://schemas.openxmlformats.org/officeDocument/2006/relationships/hyperlink" Target="https://www.ncbi.nlm.nih.gov/protein/Q15417" TargetMode="External"/><Relationship Id="rId66" Type="http://schemas.openxmlformats.org/officeDocument/2006/relationships/hyperlink" Target="https://www.ncbi.nlm.nih.gov/protein/P36222" TargetMode="External"/><Relationship Id="rId74" Type="http://schemas.openxmlformats.org/officeDocument/2006/relationships/hyperlink" Target="https://www.ncbi.nlm.nih.gov/protein/Q9P2E9" TargetMode="External"/><Relationship Id="rId5" Type="http://schemas.openxmlformats.org/officeDocument/2006/relationships/hyperlink" Target="https://www.ncbi.nlm.nih.gov/protein/P02751" TargetMode="External"/><Relationship Id="rId61" Type="http://schemas.openxmlformats.org/officeDocument/2006/relationships/hyperlink" Target="https://www.ncbi.nlm.nih.gov/protein/P0DOY2" TargetMode="External"/><Relationship Id="rId19" Type="http://schemas.openxmlformats.org/officeDocument/2006/relationships/hyperlink" Target="https://www.ncbi.nlm.nih.gov/protein/Q15166" TargetMode="External"/><Relationship Id="rId14" Type="http://schemas.openxmlformats.org/officeDocument/2006/relationships/hyperlink" Target="https://www.ncbi.nlm.nih.gov/protein/P04114" TargetMode="External"/><Relationship Id="rId22" Type="http://schemas.openxmlformats.org/officeDocument/2006/relationships/hyperlink" Target="https://www.ncbi.nlm.nih.gov/protein/Q14847" TargetMode="External"/><Relationship Id="rId27" Type="http://schemas.openxmlformats.org/officeDocument/2006/relationships/hyperlink" Target="https://www.ncbi.nlm.nih.gov/protein/P01011" TargetMode="External"/><Relationship Id="rId30" Type="http://schemas.openxmlformats.org/officeDocument/2006/relationships/hyperlink" Target="https://www.ncbi.nlm.nih.gov/protein/P20908" TargetMode="External"/><Relationship Id="rId35" Type="http://schemas.openxmlformats.org/officeDocument/2006/relationships/hyperlink" Target="https://www.ncbi.nlm.nih.gov/protein/Q86V35" TargetMode="External"/><Relationship Id="rId43" Type="http://schemas.openxmlformats.org/officeDocument/2006/relationships/hyperlink" Target="https://www.ncbi.nlm.nih.gov/protein/P02787" TargetMode="External"/><Relationship Id="rId48" Type="http://schemas.openxmlformats.org/officeDocument/2006/relationships/hyperlink" Target="https://www.ncbi.nlm.nih.gov/protein/P01009" TargetMode="External"/><Relationship Id="rId56" Type="http://schemas.openxmlformats.org/officeDocument/2006/relationships/hyperlink" Target="https://www.ncbi.nlm.nih.gov/protein/Q9UEE9" TargetMode="External"/><Relationship Id="rId64" Type="http://schemas.openxmlformats.org/officeDocument/2006/relationships/hyperlink" Target="https://www.ncbi.nlm.nih.gov/protein/P01780" TargetMode="External"/><Relationship Id="rId69" Type="http://schemas.openxmlformats.org/officeDocument/2006/relationships/hyperlink" Target="https://www.ncbi.nlm.nih.gov/protein/P14735" TargetMode="External"/><Relationship Id="rId8" Type="http://schemas.openxmlformats.org/officeDocument/2006/relationships/hyperlink" Target="https://www.ncbi.nlm.nih.gov/protein/P00751" TargetMode="External"/><Relationship Id="rId51" Type="http://schemas.openxmlformats.org/officeDocument/2006/relationships/hyperlink" Target="https://www.ncbi.nlm.nih.gov/protein/P04003" TargetMode="External"/><Relationship Id="rId72" Type="http://schemas.openxmlformats.org/officeDocument/2006/relationships/hyperlink" Target="https://www.ncbi.nlm.nih.gov/protein/P35442" TargetMode="External"/><Relationship Id="rId3" Type="http://schemas.openxmlformats.org/officeDocument/2006/relationships/hyperlink" Target="https://www.ncbi.nlm.nih.gov/protein/P01008" TargetMode="External"/><Relationship Id="rId12" Type="http://schemas.openxmlformats.org/officeDocument/2006/relationships/hyperlink" Target="https://www.ncbi.nlm.nih.gov/protein/P02766" TargetMode="External"/><Relationship Id="rId17" Type="http://schemas.openxmlformats.org/officeDocument/2006/relationships/hyperlink" Target="https://www.ncbi.nlm.nih.gov/protein/P08603" TargetMode="External"/><Relationship Id="rId25" Type="http://schemas.openxmlformats.org/officeDocument/2006/relationships/hyperlink" Target="https://www.ncbi.nlm.nih.gov/protein/P78559" TargetMode="External"/><Relationship Id="rId33" Type="http://schemas.openxmlformats.org/officeDocument/2006/relationships/hyperlink" Target="https://www.ncbi.nlm.nih.gov/protein/Q9BXN1" TargetMode="External"/><Relationship Id="rId38" Type="http://schemas.openxmlformats.org/officeDocument/2006/relationships/hyperlink" Target="https://www.ncbi.nlm.nih.gov/protein/Q99715" TargetMode="External"/><Relationship Id="rId46" Type="http://schemas.openxmlformats.org/officeDocument/2006/relationships/hyperlink" Target="https://www.ncbi.nlm.nih.gov/protein/P35542" TargetMode="External"/><Relationship Id="rId59" Type="http://schemas.openxmlformats.org/officeDocument/2006/relationships/hyperlink" Target="https://www.ncbi.nlm.nih.gov/protein/Q05682" TargetMode="External"/><Relationship Id="rId67" Type="http://schemas.openxmlformats.org/officeDocument/2006/relationships/hyperlink" Target="https://www.ncbi.nlm.nih.gov/protein/Q5TCU3" TargetMode="External"/><Relationship Id="rId20" Type="http://schemas.openxmlformats.org/officeDocument/2006/relationships/hyperlink" Target="https://www.ncbi.nlm.nih.gov/protein/P02790" TargetMode="External"/><Relationship Id="rId41" Type="http://schemas.openxmlformats.org/officeDocument/2006/relationships/hyperlink" Target="https://www.ncbi.nlm.nih.gov/protein/P36955" TargetMode="External"/><Relationship Id="rId54" Type="http://schemas.openxmlformats.org/officeDocument/2006/relationships/hyperlink" Target="https://www.ncbi.nlm.nih.gov/protein/Q14849" TargetMode="External"/><Relationship Id="rId62" Type="http://schemas.openxmlformats.org/officeDocument/2006/relationships/hyperlink" Target="https://www.ncbi.nlm.nih.gov/protein/P02656" TargetMode="External"/><Relationship Id="rId70" Type="http://schemas.openxmlformats.org/officeDocument/2006/relationships/hyperlink" Target="https://www.ncbi.nlm.nih.gov/protein/Q15293" TargetMode="External"/><Relationship Id="rId75" Type="http://schemas.openxmlformats.org/officeDocument/2006/relationships/hyperlink" Target="https://www.ncbi.nlm.nih.gov/protein/Q16352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ncbi.nlm.nih.gov/protein/P05155" TargetMode="External"/><Relationship Id="rId15" Type="http://schemas.openxmlformats.org/officeDocument/2006/relationships/hyperlink" Target="https://www.ncbi.nlm.nih.gov/protein/P00738" TargetMode="External"/><Relationship Id="rId23" Type="http://schemas.openxmlformats.org/officeDocument/2006/relationships/hyperlink" Target="https://www.ncbi.nlm.nih.gov/protein/Q96D15" TargetMode="External"/><Relationship Id="rId28" Type="http://schemas.openxmlformats.org/officeDocument/2006/relationships/hyperlink" Target="https://www.ncbi.nlm.nih.gov/protein/P01042" TargetMode="External"/><Relationship Id="rId36" Type="http://schemas.openxmlformats.org/officeDocument/2006/relationships/hyperlink" Target="https://www.ncbi.nlm.nih.gov/protein/P23142" TargetMode="External"/><Relationship Id="rId49" Type="http://schemas.openxmlformats.org/officeDocument/2006/relationships/hyperlink" Target="https://www.ncbi.nlm.nih.gov/protein/Q8N130" TargetMode="External"/><Relationship Id="rId57" Type="http://schemas.openxmlformats.org/officeDocument/2006/relationships/hyperlink" Target="https://www.ncbi.nlm.nih.gov/protein/Q15582" TargetMode="External"/><Relationship Id="rId10" Type="http://schemas.openxmlformats.org/officeDocument/2006/relationships/hyperlink" Target="https://www.ncbi.nlm.nih.gov/protein/Q14624" TargetMode="External"/><Relationship Id="rId31" Type="http://schemas.openxmlformats.org/officeDocument/2006/relationships/hyperlink" Target="https://www.ncbi.nlm.nih.gov/protein/O15460" TargetMode="External"/><Relationship Id="rId44" Type="http://schemas.openxmlformats.org/officeDocument/2006/relationships/hyperlink" Target="https://www.ncbi.nlm.nih.gov/protein/P02654" TargetMode="External"/><Relationship Id="rId52" Type="http://schemas.openxmlformats.org/officeDocument/2006/relationships/hyperlink" Target="https://www.ncbi.nlm.nih.gov/protein/P00450" TargetMode="External"/><Relationship Id="rId60" Type="http://schemas.openxmlformats.org/officeDocument/2006/relationships/hyperlink" Target="https://www.ncbi.nlm.nih.gov/protein/P13611" TargetMode="External"/><Relationship Id="rId65" Type="http://schemas.openxmlformats.org/officeDocument/2006/relationships/hyperlink" Target="https://www.ncbi.nlm.nih.gov/protein/Q8TED1" TargetMode="External"/><Relationship Id="rId73" Type="http://schemas.openxmlformats.org/officeDocument/2006/relationships/hyperlink" Target="https://www.ncbi.nlm.nih.gov/protein/Q9UGM5" TargetMode="External"/><Relationship Id="rId4" Type="http://schemas.openxmlformats.org/officeDocument/2006/relationships/hyperlink" Target="https://www.ncbi.nlm.nih.gov/protein/P02652" TargetMode="External"/><Relationship Id="rId9" Type="http://schemas.openxmlformats.org/officeDocument/2006/relationships/hyperlink" Target="https://www.ncbi.nlm.nih.gov/protein/P01023" TargetMode="External"/><Relationship Id="rId13" Type="http://schemas.openxmlformats.org/officeDocument/2006/relationships/hyperlink" Target="https://www.ncbi.nlm.nih.gov/protein/P01024" TargetMode="External"/><Relationship Id="rId18" Type="http://schemas.openxmlformats.org/officeDocument/2006/relationships/hyperlink" Target="https://www.ncbi.nlm.nih.gov/protein/Q14566" TargetMode="External"/><Relationship Id="rId39" Type="http://schemas.openxmlformats.org/officeDocument/2006/relationships/hyperlink" Target="https://www.ncbi.nlm.nih.gov/protein/P13674" TargetMode="External"/><Relationship Id="rId34" Type="http://schemas.openxmlformats.org/officeDocument/2006/relationships/hyperlink" Target="https://www.ncbi.nlm.nih.gov/protein/Q70UQ0" TargetMode="External"/><Relationship Id="rId50" Type="http://schemas.openxmlformats.org/officeDocument/2006/relationships/hyperlink" Target="https://www.ncbi.nlm.nih.gov/protein/P01857" TargetMode="External"/><Relationship Id="rId55" Type="http://schemas.openxmlformats.org/officeDocument/2006/relationships/hyperlink" Target="https://www.ncbi.nlm.nih.gov/protein/P50454" TargetMode="External"/><Relationship Id="rId76" Type="http://schemas.openxmlformats.org/officeDocument/2006/relationships/hyperlink" Target="https://www.ncbi.nlm.nih.gov/protein/O75478" TargetMode="External"/><Relationship Id="rId7" Type="http://schemas.openxmlformats.org/officeDocument/2006/relationships/hyperlink" Target="https://www.ncbi.nlm.nih.gov/protein/P02774" TargetMode="External"/><Relationship Id="rId71" Type="http://schemas.openxmlformats.org/officeDocument/2006/relationships/hyperlink" Target="https://www.ncbi.nlm.nih.gov/protein/P02655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ACE7519-A06C-5DC5-A7C9-B1407A52E681}"/>
              </a:ext>
            </a:extLst>
          </p:cNvPr>
          <p:cNvGraphicFramePr>
            <a:graphicFrameLocks noGrp="1"/>
          </p:cNvGraphicFramePr>
          <p:nvPr/>
        </p:nvGraphicFramePr>
        <p:xfrm>
          <a:off x="366210" y="650944"/>
          <a:ext cx="6308717" cy="268207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1101">
                  <a:extLst>
                    <a:ext uri="{9D8B030D-6E8A-4147-A177-3AD203B41FA5}">
                      <a16:colId xmlns:a16="http://schemas.microsoft.com/office/drawing/2014/main" val="644703819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511243781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2314506279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3281703178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405123061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1562507366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529486128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3936760169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1750583736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1005621061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1683877777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3706503975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1397042131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3998540294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4076459005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1695030468"/>
                    </a:ext>
                  </a:extLst>
                </a:gridCol>
                <a:gridCol w="371101">
                  <a:extLst>
                    <a:ext uri="{9D8B030D-6E8A-4147-A177-3AD203B41FA5}">
                      <a16:colId xmlns:a16="http://schemas.microsoft.com/office/drawing/2014/main" val="2081221120"/>
                    </a:ext>
                  </a:extLst>
                </a:gridCol>
              </a:tblGrid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SC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L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AG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B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1643828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364063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6087356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5,6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159506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8825610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4073730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5854049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7269042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4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4467071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3766757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61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1742301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7785682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5232791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4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9394919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7446915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-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6221374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9001557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-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4033123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-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5539666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-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0613942"/>
                  </a:ext>
                </a:extLst>
              </a:tr>
              <a:tr h="11596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6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9C000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98" marR="5798" marT="5798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7338374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0187C89-62BB-D2F3-5CC4-88715FFF9414}"/>
              </a:ext>
            </a:extLst>
          </p:cNvPr>
          <p:cNvSpPr txBox="1"/>
          <p:nvPr/>
        </p:nvSpPr>
        <p:spPr>
          <a:xfrm>
            <a:off x="296898" y="3496809"/>
            <a:ext cx="6508753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Patient phenotypes and characteristics for which RNA sequencing data was downloaded from GEO database under accession number #: GSE230161. ID: Patient Identification; Loc: Pressure Ulcer Location (1-sacro, 2-ischium, 3-gluteus, 4-heel, 5-trocanter, 6-others); Group: Group 1 - PU grade II; G2: Group 2 - PU grade III-IV; Hosp: Days of hospitalization; ICU: Intensive care unit; DM: Diabetes Mellitus; HBP: High Blood pressure; CHO: Hypercholesterolemia; VASC: Vascular disease; NRL: Neurologic disease; HEA: Heart disease; AGG: Antiaggregant treatment; COAG: Anticoagulant treatment; ATB: Antibiotic treatment. 1: Yes. 2: No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6198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network&#10;&#10;AI-generated content may be incorrect.">
            <a:extLst>
              <a:ext uri="{FF2B5EF4-FFF2-40B4-BE49-F238E27FC236}">
                <a16:creationId xmlns:a16="http://schemas.microsoft.com/office/drawing/2014/main" id="{86C2AB5A-A07F-FE35-9FE7-3446205235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81" b="3581"/>
          <a:stretch>
            <a:fillRect/>
          </a:stretch>
        </p:blipFill>
        <p:spPr>
          <a:xfrm>
            <a:off x="-1" y="254513"/>
            <a:ext cx="7315199" cy="797667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12C053B-C5F3-F044-1559-D70BADD6221E}"/>
              </a:ext>
            </a:extLst>
          </p:cNvPr>
          <p:cNvSpPr txBox="1"/>
          <p:nvPr/>
        </p:nvSpPr>
        <p:spPr>
          <a:xfrm>
            <a:off x="0" y="8287551"/>
            <a:ext cx="7315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IN" sz="1200">
                <a:latin typeface="Arial" panose="020B0604020202020204" pitchFamily="34" charset="0"/>
                <a:cs typeface="Arial" panose="020B0604020202020204" pitchFamily="34" charset="0"/>
              </a:rPr>
              <a:t> Disease or biofunction analysis related to T lymphocytes using IPA  based on the observed and predicted differential expressed genes and complexes in diabetic severe PU as compared to non-diabetic severe PU. N = 5 for diabetic grade III,IV pressure ulcer vs N = 5 non-diabetic grade III,IV pressure ulcer. Refer Table 1 for demographics. 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91865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3A16A04-4901-9962-591A-AE967F46E375}"/>
              </a:ext>
            </a:extLst>
          </p:cNvPr>
          <p:cNvGraphicFramePr>
            <a:graphicFrameLocks noGrp="1"/>
          </p:cNvGraphicFramePr>
          <p:nvPr/>
        </p:nvGraphicFramePr>
        <p:xfrm>
          <a:off x="244959" y="90315"/>
          <a:ext cx="6825279" cy="96165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33645">
                  <a:extLst>
                    <a:ext uri="{9D8B030D-6E8A-4147-A177-3AD203B41FA5}">
                      <a16:colId xmlns:a16="http://schemas.microsoft.com/office/drawing/2014/main" val="1774764874"/>
                    </a:ext>
                  </a:extLst>
                </a:gridCol>
                <a:gridCol w="3036586">
                  <a:extLst>
                    <a:ext uri="{9D8B030D-6E8A-4147-A177-3AD203B41FA5}">
                      <a16:colId xmlns:a16="http://schemas.microsoft.com/office/drawing/2014/main" val="2610949939"/>
                    </a:ext>
                  </a:extLst>
                </a:gridCol>
                <a:gridCol w="710120">
                  <a:extLst>
                    <a:ext uri="{9D8B030D-6E8A-4147-A177-3AD203B41FA5}">
                      <a16:colId xmlns:a16="http://schemas.microsoft.com/office/drawing/2014/main" val="595786738"/>
                    </a:ext>
                  </a:extLst>
                </a:gridCol>
                <a:gridCol w="403552">
                  <a:extLst>
                    <a:ext uri="{9D8B030D-6E8A-4147-A177-3AD203B41FA5}">
                      <a16:colId xmlns:a16="http://schemas.microsoft.com/office/drawing/2014/main" val="2578074403"/>
                    </a:ext>
                  </a:extLst>
                </a:gridCol>
                <a:gridCol w="520542">
                  <a:extLst>
                    <a:ext uri="{9D8B030D-6E8A-4147-A177-3AD203B41FA5}">
                      <a16:colId xmlns:a16="http://schemas.microsoft.com/office/drawing/2014/main" val="1102570958"/>
                    </a:ext>
                  </a:extLst>
                </a:gridCol>
                <a:gridCol w="620834">
                  <a:extLst>
                    <a:ext uri="{9D8B030D-6E8A-4147-A177-3AD203B41FA5}">
                      <a16:colId xmlns:a16="http://schemas.microsoft.com/office/drawing/2014/main" val="3561917393"/>
                    </a:ext>
                  </a:extLst>
                </a:gridCol>
              </a:tblGrid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prot ID</a:t>
                      </a:r>
                      <a:endParaRPr lang="en-US" sz="800" b="1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800" b="1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breviation</a:t>
                      </a:r>
                      <a:endParaRPr lang="en-US" sz="800" b="1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</a:t>
                      </a:r>
                      <a:endParaRPr lang="en-US" sz="800" b="1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en-US" sz="800" b="1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2439352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"/>
                        </a:rPr>
                        <a:t>Q9Y2V7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erved oligomeric Golgi complex subunit 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G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4E-0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9971001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"/>
                        </a:rPr>
                        <a:t>P01008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thrombin-III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E-0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6212602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"/>
                        </a:rPr>
                        <a:t>P0265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lipoprotein A-II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A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1E-0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2618011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"/>
                        </a:rPr>
                        <a:t>P02751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ronect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NC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5E-0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98353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"/>
                        </a:rPr>
                        <a:t>P0515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protease C1 inhibitor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8E-0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5739752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7"/>
                        </a:rPr>
                        <a:t>P0277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amin D-binding prote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D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1E-0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510854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8"/>
                        </a:rPr>
                        <a:t>P00751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ment factor 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A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8E-0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329940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9"/>
                        </a:rPr>
                        <a:t>P01023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ha-2-macroglobul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2MG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2641251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0"/>
                        </a:rPr>
                        <a:t>Q1462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-alpha-trypsin inhibitor heavy chain H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IH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5905301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1"/>
                        </a:rPr>
                        <a:t>P2962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llistat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4709193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2"/>
                        </a:rPr>
                        <a:t>P02766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thyret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HY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8111272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3"/>
                        </a:rPr>
                        <a:t>P0102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ment C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5428075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4"/>
                        </a:rPr>
                        <a:t>P0411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lipoprotein B-100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4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1487834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5"/>
                        </a:rPr>
                        <a:t>P00738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toglob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T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5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1514032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6"/>
                        </a:rPr>
                        <a:t>P02647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lipoprotein A-I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A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9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3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5058506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7"/>
                        </a:rPr>
                        <a:t>P08603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ment factor H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AH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6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4645968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8"/>
                        </a:rPr>
                        <a:t>Q14566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replication licensing factor MCM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M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2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4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6405081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19"/>
                        </a:rPr>
                        <a:t>Q15166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um paraoxonase/lactonase 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N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9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9261061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0"/>
                        </a:rPr>
                        <a:t>P02790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pex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1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1769197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9PGZ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desmo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9PGZ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8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2337693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1"/>
                        </a:rPr>
                        <a:t>Q9NR99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rix-remodeling-associated protein 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XRA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3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4524759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2"/>
                        </a:rPr>
                        <a:t>Q14847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 and SH3 domain protein 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P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8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4560252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3"/>
                        </a:rPr>
                        <a:t>Q96D1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iculocalbin-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CN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5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3955796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4"/>
                        </a:rPr>
                        <a:t>Q96AY3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idyl-prolyl cis-trans isomerase FKBP10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KB10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0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1579300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5"/>
                        </a:rPr>
                        <a:t>P78559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tubule-associated protein 1A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1A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5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0548507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6"/>
                        </a:rPr>
                        <a:t>P01031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ment C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0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9746514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7"/>
                        </a:rPr>
                        <a:t>P01011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ha-1-antichymotryps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T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5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4524749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8"/>
                        </a:rPr>
                        <a:t>P0104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ninogen-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G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5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3566922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9"/>
                        </a:rPr>
                        <a:t>P05546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rin cofactor 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7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2716571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0"/>
                        </a:rPr>
                        <a:t>P20908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V) cha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5A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8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3409186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1"/>
                        </a:rPr>
                        <a:t>O15460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yl 4-hydroxylase subunit alpha-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4HA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8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574920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2"/>
                        </a:rPr>
                        <a:t>Q8TD16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it-IT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bicaudal D homolog 2</a:t>
                      </a:r>
                      <a:endParaRPr lang="it-IT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CD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9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6801309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3"/>
                        </a:rPr>
                        <a:t>Q9BXN1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or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7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4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3249825"/>
                  </a:ext>
                </a:extLst>
              </a:tr>
              <a:tr h="103437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4"/>
                        </a:rPr>
                        <a:t>Q70UQ0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 of nuclear factor kappa-B kinase-interacting prote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KIP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0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0368875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5"/>
                        </a:rPr>
                        <a:t>Q86V3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um-binding protein 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BP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95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7620363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6"/>
                        </a:rPr>
                        <a:t>P2314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ulin-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LN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1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6616384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7"/>
                        </a:rPr>
                        <a:t>P07358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fr-F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ment component C8 beta chain</a:t>
                      </a:r>
                      <a:endParaRPr lang="fr-FR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8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8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9609846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8"/>
                        </a:rPr>
                        <a:t>Q9971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alpha-1(XII) cha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CA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3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5543728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39"/>
                        </a:rPr>
                        <a:t>P1367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yl 4-hydroxylase subunit alpha-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4HA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5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2273546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0"/>
                        </a:rPr>
                        <a:t>Q96IY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xypeptidase B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PB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4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1390734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1"/>
                        </a:rPr>
                        <a:t>P3695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gment epithelium-derived factor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DF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6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966915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2"/>
                        </a:rPr>
                        <a:t>Q7LBR1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rged multivesicular body protein 1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M1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0E-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8340733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3"/>
                        </a:rPr>
                        <a:t>P02787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ransferr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FE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6167677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4"/>
                        </a:rPr>
                        <a:t>P0265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lipoprotein C-I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C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6162183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5"/>
                        </a:rPr>
                        <a:t>Q9Y680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idyl-prolyl cis-trans isomerase FKBP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KBP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3576685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6"/>
                        </a:rPr>
                        <a:t>P3554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um amyloid A-4 prote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A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8862850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7"/>
                        </a:rPr>
                        <a:t>P0C0L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ment C4-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4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5560294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8"/>
                        </a:rPr>
                        <a:t>P01009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ha-1-antitryps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AT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7721339"/>
                  </a:ext>
                </a:extLst>
              </a:tr>
              <a:tr h="126051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49"/>
                        </a:rPr>
                        <a:t>Q8N130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-dependent phosphate transport protein 2C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T2C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4466678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0"/>
                        </a:rPr>
                        <a:t>P01857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globulin heavy constant gamma 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HG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8551923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1"/>
                        </a:rPr>
                        <a:t>P04003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4b-binding protein alpha cha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4BPA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7040234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2"/>
                        </a:rPr>
                        <a:t>P00450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ruloplasm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RU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4743967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3"/>
                        </a:rPr>
                        <a:t>Q1455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disulfide-isomerase A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IA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1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111405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4"/>
                        </a:rPr>
                        <a:t>Q14849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-related lipid transfer protein 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7187707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5"/>
                        </a:rPr>
                        <a:t>P50454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 H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H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3235065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6"/>
                        </a:rPr>
                        <a:t>Q9UEE9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aniofacial development protein 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DP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9813913"/>
                  </a:ext>
                </a:extLst>
              </a:tr>
              <a:tr h="162185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7"/>
                        </a:rPr>
                        <a:t>Q1558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forming growth factor-beta-induced protein ig-h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H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3747048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8"/>
                        </a:rPr>
                        <a:t>Q15417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ponin-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N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9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3631899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59"/>
                        </a:rPr>
                        <a:t>Q0568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desmo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D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9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7752200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0"/>
                        </a:rPr>
                        <a:t>P13611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sican core prote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PG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7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0421198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1"/>
                        </a:rPr>
                        <a:t>P0DOY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globulin lambda constant 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LC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7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5636295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2"/>
                        </a:rPr>
                        <a:t>P02656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lipoprotein C-III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C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7996438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3"/>
                        </a:rPr>
                        <a:t>Q32P28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yl 3-hydroxylase 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H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6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023038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4"/>
                        </a:rPr>
                        <a:t>P01780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globulin heavy variable 3–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V30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8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4306739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5"/>
                        </a:rPr>
                        <a:t>Q8TED1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able glutathione peroxidase 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X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6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1567036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6"/>
                        </a:rPr>
                        <a:t>P3622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tinase-3-like protein 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3L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8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1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3775316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7"/>
                        </a:rPr>
                        <a:t>Q5TCU3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opomyosin beta cha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7"/>
                        </a:rPr>
                        <a:t>Q5TCU3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5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5607176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8"/>
                        </a:rPr>
                        <a:t>O43488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latoxin B1 aldehyde reductase member 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K7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7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8061285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69"/>
                        </a:rPr>
                        <a:t>P1473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-degrading enzyme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8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2292297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70"/>
                        </a:rPr>
                        <a:t>Q15293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iculocalbin-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CN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4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8752292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71"/>
                        </a:rPr>
                        <a:t>P0265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lipoprotein C-II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C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9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6272732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72"/>
                        </a:rPr>
                        <a:t>P3544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rombospondin-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P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4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4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1925713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73"/>
                        </a:rPr>
                        <a:t>Q9UGM5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tuin-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TUB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6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0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787913"/>
                  </a:ext>
                </a:extLst>
              </a:tr>
              <a:tr h="108124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74"/>
                        </a:rPr>
                        <a:t>Q9P2E9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some-binding protein 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RBP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0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4734402"/>
                  </a:ext>
                </a:extLst>
              </a:tr>
              <a:tr h="54062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75"/>
                        </a:rPr>
                        <a:t>Q16352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ha-internexin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NX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3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8E-0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487698"/>
                  </a:ext>
                </a:extLst>
              </a:tr>
              <a:tr h="110581"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sng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76"/>
                        </a:rPr>
                        <a:t>O75478</a:t>
                      </a:r>
                      <a:endParaRPr lang="en-US" sz="800" b="0" i="0" u="sng" strike="noStrike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criptional adapter 2-alpha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buNone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D2A</a:t>
                      </a:r>
                      <a:endParaRPr lang="en-US" sz="800" b="0" i="0" u="none" strike="noStrike" dirty="0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1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</a:t>
                      </a:r>
                      <a:endParaRPr lang="en-US" sz="800" b="0" i="0" u="none" strike="noStrike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>
                        <a:buNone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6E-02</a:t>
                      </a:r>
                      <a:endParaRPr lang="en-US" sz="800" b="0" i="0" u="none" strike="noStrike" dirty="0">
                        <a:solidFill>
                          <a:srgbClr val="1B1B1B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57" marR="2457" marT="2457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139205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4F957AF-C282-ABA2-5F84-C993CC9981D9}"/>
              </a:ext>
            </a:extLst>
          </p:cNvPr>
          <p:cNvSpPr txBox="1"/>
          <p:nvPr/>
        </p:nvSpPr>
        <p:spPr>
          <a:xfrm>
            <a:off x="142527" y="9669502"/>
            <a:ext cx="703014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: Differentially expressed proteins identified by tandem mass tag labeling in pressure ulcer tissue and control tissue reported by Baldan-Martin et al. Adv Wound Care (New Rochelle). 2020. </a:t>
            </a:r>
          </a:p>
        </p:txBody>
      </p:sp>
    </p:spTree>
    <p:extLst>
      <p:ext uri="{BB962C8B-B14F-4D97-AF65-F5344CB8AC3E}">
        <p14:creationId xmlns:p14="http://schemas.microsoft.com/office/powerpoint/2010/main" val="1190213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8</TotalTime>
  <Words>1269</Words>
  <Application>Microsoft Office PowerPoint</Application>
  <PresentationFormat>Custom</PresentationFormat>
  <Paragraphs>82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nhaiya Singh</dc:creator>
  <cp:lastModifiedBy>Kanhaiya Singh</cp:lastModifiedBy>
  <cp:revision>1</cp:revision>
  <dcterms:created xsi:type="dcterms:W3CDTF">2025-10-31T17:34:10Z</dcterms:created>
  <dcterms:modified xsi:type="dcterms:W3CDTF">2025-11-22T21:20:53Z</dcterms:modified>
</cp:coreProperties>
</file>